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1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CF49B97-4417-4E94-A187-7C07D3A8F6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8772B64-B114-423E-85CB-1D4C8158F5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9997376-1095-476F-A870-9B113567A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B8B2956-59EC-4680-B584-A2DD86709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A4BC857-EDCA-4E26-A071-7EEBEF9D41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837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E9DE19F-767B-4EE9-A822-469147B035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2F36FD2-A6A5-4287-9D90-48B40D0A10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FB6988B-398E-4F57-AE9B-56D12716B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D51C13F-1F61-46B4-8F24-7F57AFA410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418561A-AE0D-4536-B783-9B47DD77C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4540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F6A6C9A-029A-4A5F-9419-984B517CF5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75F1ACB-5128-46F2-AA8C-DE9572C3FF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8E8DF3D-369C-4DCC-9CCC-2F9C79053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6646E8-CD96-4BAB-B865-8DF19F8FB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1EE0A70-2687-428F-AD7A-C4A67B7CD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4347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3491C5B-BFA9-46BD-AC36-81ACBF8F3B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24D1D90-292C-4FDC-AECD-A7B2D80831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20BC032-C04E-43A2-9017-96489EFD5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21B9AC4-6E26-4485-97D2-45DE3FB5F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E4A06C8-7385-40EB-90B6-EBA54E2FF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3217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FEC5AE1-C434-44FC-8090-EE71DEB668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B1A9D7A-B730-4644-AE3F-2B6FDF8181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1475095-9168-47A4-96B3-5F0496488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8157418-F350-4D25-9BF6-324A90D20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A16BD73-F90C-4DB5-9590-AE3D5CEBF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5178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25AC1A8-4D6A-4E30-9EA0-6DB0C0EA10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1BA461D-31D2-42C9-8ECD-CACEA58287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C01DD0F-9EDF-49F4-9E81-1685AB446E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836E461-7403-44E7-A392-9A64F0CBB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C0BA9CC-0768-4DDE-B894-38C24E6EDA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A2989FE-C98C-4DEA-A0D2-8359814E8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4453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EA20247-75C0-4D10-BA4C-13377A0BD9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5754D5B-0363-4594-9FD1-9DF78016CA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BCB2C02-7A9E-4D80-9990-B1BE216F7A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AB9CC55-ED98-45E8-A6FC-26DFF70F07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D3531F89-0773-4E4E-A1DA-ACAA107616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BE672D4-94FF-469D-A716-89E8075AF6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D0532DB-7A47-4E81-83E9-2E219EDDF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681FECB2-32D8-4DFD-A320-3A8C8D481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4867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1C2812F-C687-414D-8D0C-35E1E162FF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9C339A8D-D2AB-4E61-A3BD-7C2D182BD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F442EBE-BABF-4C50-BBB5-5CB27C803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36EB685-15C6-4336-97E5-2885E3457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8384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DF2151F-B2A5-438F-B70B-B07536AAAF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83550DF-FE7F-4461-A67E-C9293D08E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F9EE090B-56B1-45AC-86F6-89EBBF10F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1124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F891E1-A867-4050-9233-BB9B88C293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6B850D4-04E1-4FF7-A6AE-4C69519160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9927A78-A111-457C-B76E-AD744E49CB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56ED13A-91AD-4EE7-95CD-671803D26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AFEF515-9625-4E02-8FC4-01CCC2F3DB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A3B5DEE-F313-4B91-AD89-3E062E0A8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726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EA30D3A-606D-4318-80D3-2955FDC78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7FA3297B-93B9-4479-9808-DD5FB656F8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018F17B-18CC-4910-9628-A719B1E65B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E976E1A-04A7-43AE-A251-8485ACFEB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3756EB2-C790-438A-8BA7-280A4918F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5FF78AD-AF37-4710-AF2E-F844C1B1A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9379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86E3E66E-DF01-478B-8392-B4782BB7FD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B0C0EE4-C4F0-440E-BFBC-642AE99430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A07815E-ECC4-4679-860B-03B6205C58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069E9A-12AC-4718-AC41-6C9EEC6968CE}" type="datetimeFigureOut">
              <a:rPr lang="ko-KR" altLang="en-US" smtClean="0"/>
              <a:t>2022-06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47B2FBB-00D0-4BAA-9066-5ABAADE700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E56F831-29F5-43B0-8EC8-5B7F4D6806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E3C4E-BC5D-47C0-8D95-D9762B17A6E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4859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B521651-9A0C-4EDB-B2FC-17232AF6CE1A}"/>
              </a:ext>
            </a:extLst>
          </p:cNvPr>
          <p:cNvSpPr txBox="1"/>
          <p:nvPr/>
        </p:nvSpPr>
        <p:spPr>
          <a:xfrm>
            <a:off x="249978" y="15711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E7A4BD0-4B61-460C-8B1B-502F0F441463}"/>
              </a:ext>
            </a:extLst>
          </p:cNvPr>
          <p:cNvSpPr txBox="1"/>
          <p:nvPr/>
        </p:nvSpPr>
        <p:spPr>
          <a:xfrm>
            <a:off x="4718358" y="15711"/>
            <a:ext cx="447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id="{D0BF55DF-290F-4866-9978-74C33EFB2B4D}"/>
              </a:ext>
            </a:extLst>
          </p:cNvPr>
          <p:cNvGrpSpPr/>
          <p:nvPr/>
        </p:nvGrpSpPr>
        <p:grpSpPr>
          <a:xfrm>
            <a:off x="247481" y="957752"/>
            <a:ext cx="3958884" cy="4574530"/>
            <a:chOff x="247481" y="1274275"/>
            <a:chExt cx="3958884" cy="4574530"/>
          </a:xfrm>
        </p:grpSpPr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41F2ED1D-CCF2-4711-BD32-847C9F9DFD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29" t="7958" r="24072" b="15747"/>
            <a:stretch/>
          </p:blipFill>
          <p:spPr>
            <a:xfrm>
              <a:off x="247481" y="1548241"/>
              <a:ext cx="3958884" cy="3639395"/>
            </a:xfrm>
            <a:prstGeom prst="rect">
              <a:avLst/>
            </a:prstGeom>
          </p:spPr>
        </p:pic>
        <p:sp>
          <p:nvSpPr>
            <p:cNvPr id="8" name="사각형: 둥근 모서리 7">
              <a:extLst>
                <a:ext uri="{FF2B5EF4-FFF2-40B4-BE49-F238E27FC236}">
                  <a16:creationId xmlns:a16="http://schemas.microsoft.com/office/drawing/2014/main" id="{1CE91119-44F8-4FA0-9287-23F778360A75}"/>
                </a:ext>
              </a:extLst>
            </p:cNvPr>
            <p:cNvSpPr/>
            <p:nvPr/>
          </p:nvSpPr>
          <p:spPr>
            <a:xfrm>
              <a:off x="1826225" y="1274275"/>
              <a:ext cx="1664233" cy="547932"/>
            </a:xfrm>
            <a:prstGeom prst="roundRect">
              <a:avLst/>
            </a:prstGeom>
            <a:solidFill>
              <a:srgbClr val="DC5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Ins="36000" rtlCol="0" anchor="ctr"/>
            <a:lstStyle/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coholism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romatin silencing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leosome assembly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사각형: 둥근 모서리 8">
              <a:extLst>
                <a:ext uri="{FF2B5EF4-FFF2-40B4-BE49-F238E27FC236}">
                  <a16:creationId xmlns:a16="http://schemas.microsoft.com/office/drawing/2014/main" id="{78C4E4B2-0212-4B3C-9BDD-95FE4C943D6A}"/>
                </a:ext>
              </a:extLst>
            </p:cNvPr>
            <p:cNvSpPr/>
            <p:nvPr/>
          </p:nvSpPr>
          <p:spPr>
            <a:xfrm>
              <a:off x="519075" y="5309759"/>
              <a:ext cx="2178866" cy="539046"/>
            </a:xfrm>
            <a:prstGeom prst="roundRect">
              <a:avLst/>
            </a:prstGeom>
            <a:solidFill>
              <a:srgbClr val="5CB3D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Ins="36000" rtlCol="0" anchor="ctr"/>
            <a:lstStyle/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ystemic lupus erythematosus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coholism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tibacterial humoral response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그룹 9">
            <a:extLst>
              <a:ext uri="{FF2B5EF4-FFF2-40B4-BE49-F238E27FC236}">
                <a16:creationId xmlns:a16="http://schemas.microsoft.com/office/drawing/2014/main" id="{B5ECFEE9-357A-4858-8E83-33177F40F635}"/>
              </a:ext>
            </a:extLst>
          </p:cNvPr>
          <p:cNvGrpSpPr/>
          <p:nvPr/>
        </p:nvGrpSpPr>
        <p:grpSpPr>
          <a:xfrm>
            <a:off x="4700523" y="87005"/>
            <a:ext cx="7198727" cy="6153275"/>
            <a:chOff x="4700523" y="333187"/>
            <a:chExt cx="7198727" cy="6153275"/>
          </a:xfrm>
        </p:grpSpPr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40ACF0D2-D3BC-4A60-AA2E-6A26257C07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8" t="528" r="1613"/>
            <a:stretch/>
          </p:blipFill>
          <p:spPr>
            <a:xfrm>
              <a:off x="6249901" y="333188"/>
              <a:ext cx="5102417" cy="6092982"/>
            </a:xfrm>
            <a:prstGeom prst="rect">
              <a:avLst/>
            </a:prstGeom>
          </p:spPr>
        </p:pic>
        <p:sp>
          <p:nvSpPr>
            <p:cNvPr id="12" name="사각형: 둥근 모서리 11">
              <a:extLst>
                <a:ext uri="{FF2B5EF4-FFF2-40B4-BE49-F238E27FC236}">
                  <a16:creationId xmlns:a16="http://schemas.microsoft.com/office/drawing/2014/main" id="{C5B2A27A-D584-4458-A26C-FC72569E748B}"/>
                </a:ext>
              </a:extLst>
            </p:cNvPr>
            <p:cNvSpPr/>
            <p:nvPr/>
          </p:nvSpPr>
          <p:spPr>
            <a:xfrm>
              <a:off x="4758985" y="2723106"/>
              <a:ext cx="1664233" cy="1043134"/>
            </a:xfrm>
            <a:prstGeom prst="roundRect">
              <a:avLst/>
            </a:prstGeom>
            <a:solidFill>
              <a:srgbClr val="DC5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Ins="36000" rtlCol="0" anchor="ctr"/>
            <a:lstStyle/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NA repair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division/cell cycle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A transport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RNA surveillance pathway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A degradation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사각형: 둥근 모서리 12">
              <a:extLst>
                <a:ext uri="{FF2B5EF4-FFF2-40B4-BE49-F238E27FC236}">
                  <a16:creationId xmlns:a16="http://schemas.microsoft.com/office/drawing/2014/main" id="{26C6C790-0469-4EFD-BAF2-124E8BF8D2A7}"/>
                </a:ext>
              </a:extLst>
            </p:cNvPr>
            <p:cNvSpPr/>
            <p:nvPr/>
          </p:nvSpPr>
          <p:spPr>
            <a:xfrm>
              <a:off x="9784211" y="333187"/>
              <a:ext cx="2115039" cy="898081"/>
            </a:xfrm>
            <a:prstGeom prst="roundRect">
              <a:avLst/>
            </a:prstGeom>
            <a:solidFill>
              <a:srgbClr val="EAE51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Ins="0" rtlCol="0" anchor="ctr"/>
            <a:lstStyle/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xophagy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tein transport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gulation of establishment of protein localization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ndocytosis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사각형: 둥근 모서리 13">
              <a:extLst>
                <a:ext uri="{FF2B5EF4-FFF2-40B4-BE49-F238E27FC236}">
                  <a16:creationId xmlns:a16="http://schemas.microsoft.com/office/drawing/2014/main" id="{01144103-1187-4717-A873-B2EDD336E6B3}"/>
                </a:ext>
              </a:extLst>
            </p:cNvPr>
            <p:cNvSpPr/>
            <p:nvPr/>
          </p:nvSpPr>
          <p:spPr>
            <a:xfrm>
              <a:off x="5281551" y="861446"/>
              <a:ext cx="1664233" cy="898081"/>
            </a:xfrm>
            <a:prstGeom prst="roundRect">
              <a:avLst/>
            </a:prstGeom>
            <a:solidFill>
              <a:srgbClr val="7EC3E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Ins="36000" rtlCol="0" anchor="ctr"/>
            <a:lstStyle/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A splicing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RNA processing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tein export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tein processing in endoplasmic reticulum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사각형: 둥근 모서리 14">
              <a:extLst>
                <a:ext uri="{FF2B5EF4-FFF2-40B4-BE49-F238E27FC236}">
                  <a16:creationId xmlns:a16="http://schemas.microsoft.com/office/drawing/2014/main" id="{05835B5B-D697-430D-AB43-D42453BAC3A6}"/>
                </a:ext>
              </a:extLst>
            </p:cNvPr>
            <p:cNvSpPr/>
            <p:nvPr/>
          </p:nvSpPr>
          <p:spPr>
            <a:xfrm>
              <a:off x="9728621" y="5588381"/>
              <a:ext cx="2143470" cy="898081"/>
            </a:xfrm>
            <a:prstGeom prst="roundRect">
              <a:avLst/>
            </a:prstGeom>
            <a:solidFill>
              <a:srgbClr val="ABDB7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Ins="36000" rtlCol="0" anchor="ctr"/>
            <a:lstStyle/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crotubule bundle formation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mbrane depolarization during action potential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ng-term depression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paminergic synapse</a:t>
              </a:r>
            </a:p>
          </p:txBody>
        </p:sp>
        <p:sp>
          <p:nvSpPr>
            <p:cNvPr id="16" name="사각형: 둥근 모서리 15">
              <a:extLst>
                <a:ext uri="{FF2B5EF4-FFF2-40B4-BE49-F238E27FC236}">
                  <a16:creationId xmlns:a16="http://schemas.microsoft.com/office/drawing/2014/main" id="{AE3DC4ED-893E-4430-BF30-839E42A9A510}"/>
                </a:ext>
              </a:extLst>
            </p:cNvPr>
            <p:cNvSpPr/>
            <p:nvPr/>
          </p:nvSpPr>
          <p:spPr>
            <a:xfrm>
              <a:off x="4700523" y="5139341"/>
              <a:ext cx="2290526" cy="898081"/>
            </a:xfrm>
            <a:prstGeom prst="roundRect">
              <a:avLst/>
            </a:prstGeom>
            <a:solidFill>
              <a:srgbClr val="7E84F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Ins="0" rtlCol="0" anchor="ctr"/>
            <a:lstStyle/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gulation of transcription, DNA-templated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st-embryonic development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ppo signaling pathway</a:t>
              </a:r>
            </a:p>
            <a:p>
              <a:pPr marL="90488" indent="-90488">
                <a:buFont typeface="Wingdings" panose="05000000000000000000" pitchFamily="2" charset="2"/>
                <a:buChar char="§"/>
              </a:pPr>
              <a:r>
                <a:rPr lang="en-US" altLang="ko-KR" sz="11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nt</a:t>
              </a: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ignaling pathway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C4A08CF0-1B8F-4961-A6AC-05E858856B19}"/>
              </a:ext>
            </a:extLst>
          </p:cNvPr>
          <p:cNvSpPr txBox="1"/>
          <p:nvPr/>
        </p:nvSpPr>
        <p:spPr>
          <a:xfrm>
            <a:off x="247481" y="6214293"/>
            <a:ext cx="11441785" cy="6121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rotein interaction network of differentially expressed genes in Nuero2a cells in response to ethanol. (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Protein interaction network of genes upregulated in E72h compared to E24h. (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Protein interaction network of genes downregulated in E72h compared to E24h.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4278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</TotalTime>
  <Words>126</Words>
  <Application>Microsoft Office PowerPoint</Application>
  <PresentationFormat>와이드스크린</PresentationFormat>
  <Paragraphs>3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Wingdings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hoi miran</dc:creator>
  <cp:lastModifiedBy>ajoumc</cp:lastModifiedBy>
  <cp:revision>6</cp:revision>
  <dcterms:created xsi:type="dcterms:W3CDTF">2021-06-29T02:24:48Z</dcterms:created>
  <dcterms:modified xsi:type="dcterms:W3CDTF">2022-06-26T08:54:22Z</dcterms:modified>
</cp:coreProperties>
</file>